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85" r:id="rId2"/>
    <p:sldId id="284" r:id="rId3"/>
    <p:sldId id="280" r:id="rId4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iroyuki Sasaki" initials="H.S." lastIdx="1" clrIdx="0">
    <p:extLst>
      <p:ext uri="{19B8F6BF-5375-455C-9EA6-DF929625EA0E}">
        <p15:presenceInfo xmlns:p15="http://schemas.microsoft.com/office/powerpoint/2012/main" userId="Hiroyuki Sasak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C80"/>
    <a:srgbClr val="FF0000"/>
    <a:srgbClr val="FC00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09" autoAdjust="0"/>
    <p:restoredTop sz="94578" autoAdjust="0"/>
  </p:normalViewPr>
  <p:slideViewPr>
    <p:cSldViewPr snapToGrid="0">
      <p:cViewPr varScale="1">
        <p:scale>
          <a:sx n="78" d="100"/>
          <a:sy n="78" d="100"/>
        </p:scale>
        <p:origin x="244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30561;&#30496;&#23455;&#39443;\240621%20&#23455;&#39443;&#32080;&#26524;\&#33075;&#33144;&#30456;&#38306;&#23455;&#39443;&#12288;&#33075;&#27874;&#12487;&#12540;&#12479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20230424\OneDrive%20-%20Calbee,Inc\&#12487;&#12473;&#12463;&#12488;&#12483;&#12503;\&#12459;&#12523;&#12499;&#12540;&#30740;&#31350;\&#30561;&#30496;&#23455;&#39443;\240621%20&#23455;&#39443;&#32080;&#26524;\&#33075;&#33144;&#30456;&#38306;&#23455;&#39443;&#12288;&#33075;&#27874;&#12487;&#12540;&#12479;&#12414;&#12392;&#12417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排便状況!$C$1</c:f>
              <c:strCache>
                <c:ptCount val="1"/>
                <c:pt idx="0">
                  <c:v>排便回数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排便状況!$E$3,排便状況!$E$30,排便状況!$E$57)</c:f>
                <c:numCache>
                  <c:formatCode>General</c:formatCode>
                  <c:ptCount val="3"/>
                  <c:pt idx="0">
                    <c:v>0.75324208688025096</c:v>
                  </c:pt>
                  <c:pt idx="1">
                    <c:v>0.93307779253954126</c:v>
                  </c:pt>
                  <c:pt idx="2">
                    <c:v>0.89474566250404397</c:v>
                  </c:pt>
                </c:numCache>
              </c:numRef>
            </c:plus>
            <c:minus>
              <c:numRef>
                <c:f>(排便状況!$E$3,排便状況!$E$30,排便状況!$E$57)</c:f>
                <c:numCache>
                  <c:formatCode>General</c:formatCode>
                  <c:ptCount val="3"/>
                  <c:pt idx="0">
                    <c:v>0.75324208688025096</c:v>
                  </c:pt>
                  <c:pt idx="1">
                    <c:v>0.93307779253954126</c:v>
                  </c:pt>
                  <c:pt idx="2">
                    <c:v>0.894745662504043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排便状況!$A$2,排便状況!$A$29,排便状況!$A$56)</c:f>
              <c:strCache>
                <c:ptCount val="3"/>
                <c:pt idx="0">
                  <c:v>0 wk</c:v>
                </c:pt>
                <c:pt idx="1">
                  <c:v>4 wk</c:v>
                </c:pt>
                <c:pt idx="2">
                  <c:v>8 wk</c:v>
                </c:pt>
              </c:strCache>
            </c:strRef>
          </c:cat>
          <c:val>
            <c:numRef>
              <c:f>(排便状況!$E$2,排便状況!$E$29,排便状況!$E$56)</c:f>
              <c:numCache>
                <c:formatCode>General</c:formatCode>
                <c:ptCount val="3"/>
                <c:pt idx="0">
                  <c:v>6.3703703703703702</c:v>
                </c:pt>
                <c:pt idx="1">
                  <c:v>7.7407407407407405</c:v>
                </c:pt>
                <c:pt idx="2">
                  <c:v>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8B3-4A9D-8A97-E29BE5B807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2841704"/>
        <c:axId val="672842688"/>
      </c:lineChart>
      <c:catAx>
        <c:axId val="672841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2842688"/>
        <c:crosses val="autoZero"/>
        <c:auto val="1"/>
        <c:lblAlgn val="ctr"/>
        <c:lblOffset val="100"/>
        <c:noMultiLvlLbl val="0"/>
      </c:catAx>
      <c:valAx>
        <c:axId val="672842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2841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排便状況!$F$1</c:f>
              <c:strCache>
                <c:ptCount val="1"/>
                <c:pt idx="0">
                  <c:v>便性状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排便状況!$I$3,排便状況!$I$30,排便状況!$I$57)</c:f>
                <c:numCache>
                  <c:formatCode>General</c:formatCode>
                  <c:ptCount val="3"/>
                  <c:pt idx="0">
                    <c:v>0.16306653015674291</c:v>
                  </c:pt>
                  <c:pt idx="1">
                    <c:v>0.14814814814814806</c:v>
                  </c:pt>
                  <c:pt idx="2">
                    <c:v>0.15408338784034151</c:v>
                  </c:pt>
                </c:numCache>
              </c:numRef>
            </c:plus>
            <c:minus>
              <c:numRef>
                <c:f>(排便状況!$I$3,排便状況!$I$30,排便状況!$I$57)</c:f>
                <c:numCache>
                  <c:formatCode>General</c:formatCode>
                  <c:ptCount val="3"/>
                  <c:pt idx="0">
                    <c:v>0.16306653015674291</c:v>
                  </c:pt>
                  <c:pt idx="1">
                    <c:v>0.14814814814814806</c:v>
                  </c:pt>
                  <c:pt idx="2">
                    <c:v>0.154083387840341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排便状況!$A$2,排便状況!$A$29,排便状況!$A$56)</c:f>
              <c:strCache>
                <c:ptCount val="3"/>
                <c:pt idx="0">
                  <c:v>0 wk</c:v>
                </c:pt>
                <c:pt idx="1">
                  <c:v>4 wk</c:v>
                </c:pt>
                <c:pt idx="2">
                  <c:v>8 wk</c:v>
                </c:pt>
              </c:strCache>
            </c:strRef>
          </c:cat>
          <c:val>
            <c:numRef>
              <c:f>(排便状況!$I$2,排便状況!$I$29,排便状況!$I$56)</c:f>
              <c:numCache>
                <c:formatCode>General</c:formatCode>
                <c:ptCount val="3"/>
                <c:pt idx="0">
                  <c:v>3.8888888888888888</c:v>
                </c:pt>
                <c:pt idx="1">
                  <c:v>4.1481481481481479</c:v>
                </c:pt>
                <c:pt idx="2">
                  <c:v>4.22222222222222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228-4907-A732-F558CA5A74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672841704"/>
        <c:axId val="672842688"/>
      </c:lineChart>
      <c:catAx>
        <c:axId val="6728417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2842688"/>
        <c:crosses val="autoZero"/>
        <c:auto val="1"/>
        <c:lblAlgn val="ctr"/>
        <c:lblOffset val="100"/>
        <c:noMultiLvlLbl val="0"/>
      </c:catAx>
      <c:valAx>
        <c:axId val="6728426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72841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aseline="0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909260-4C06-4AFE-AFD1-FA47943E24FC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FE1247-8D11-42A8-B7F9-8C9D1EDC80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5169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876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480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5718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9382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98140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8426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8405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14188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7994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266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788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C532E-AAF0-4717-AB44-C5BB3BE04835}" type="datetimeFigureOut">
              <a:rPr kumimoji="1" lang="ja-JP" altLang="en-US" smtClean="0"/>
              <a:t>2025/3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8FD99-428C-49E7-A3D0-34589369A6A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294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Fig.1</a:t>
            </a:r>
            <a:endParaRPr lang="ja-JP" altLang="en-US" sz="1069" dirty="0"/>
          </a:p>
        </p:txBody>
      </p:sp>
      <p:graphicFrame>
        <p:nvGraphicFramePr>
          <p:cNvPr id="9" name="表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5880710"/>
              </p:ext>
            </p:extLst>
          </p:nvPr>
        </p:nvGraphicFramePr>
        <p:xfrm>
          <a:off x="1163818" y="150254"/>
          <a:ext cx="4626949" cy="36490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36490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ruitment of subjects &amp; Pre-screening (n=11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</a:tbl>
          </a:graphicData>
        </a:graphic>
      </p:graphicFrame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6992260"/>
              </p:ext>
            </p:extLst>
          </p:nvPr>
        </p:nvGraphicFramePr>
        <p:xfrm>
          <a:off x="1163818" y="1070270"/>
          <a:ext cx="4626949" cy="11277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reening (n=5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)Epworth Sleepiness Scale score of ≥ 11 were excluded.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) those judged to be under high stress based on the Brief Job Stress Questionnaire were included (score ≥ 77 in area B or total score ≥ 76 in areas A and C and ≥ 63 in area B).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12" name="直線矢印コネクタ 11"/>
          <p:cNvCxnSpPr/>
          <p:nvPr/>
        </p:nvCxnSpPr>
        <p:spPr>
          <a:xfrm>
            <a:off x="3477294" y="528034"/>
            <a:ext cx="0" cy="51971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4" name="表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39046831"/>
              </p:ext>
            </p:extLst>
          </p:nvPr>
        </p:nvGraphicFramePr>
        <p:xfrm>
          <a:off x="630201" y="2753145"/>
          <a:ext cx="5694182" cy="423672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694182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st period (n=27)</a:t>
                      </a:r>
                      <a:endParaRPr kumimoji="1" lang="ja-JP" alt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) had taken or had planned to take anti-allergy medications, sleeping pills, or sleeping aids in the month preceding the test date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2) regular intake of supplements at a rate of more than three times/week 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) history of serious diseases or current illnesse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4) incidence of chronic or acute serious infection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5) scheduled to receive vaccinations during the study period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6) pregnant or planning to become pregnant or breastfeeding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7) habitual drinking of alcohol more than three times/week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8) irregular eating habit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9) body mass index (BMI) ≥ 30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0) plans to significantly alter their lifestyle during the study period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1) primary caretaker for persons requiring nursing care or an infant or may have their sleep disturbed by other external factor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2) food allergie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3) participation in a clinical study for other medicines or health foods or planning to participate in another clinical study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4) not engaged in full-time employment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5) working in shifts or late night work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6) non-possession of a smartphone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7) unable to install the Fitbit applications on their smartphones</a:t>
                      </a:r>
                    </a:p>
                    <a:p>
                      <a:pPr algn="ctr"/>
                      <a:r>
                        <a:rPr kumimoji="1" lang="en-US" altLang="ja-JP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8) less than three bowel movements/week. 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15" name="直線矢印コネクタ 14"/>
          <p:cNvCxnSpPr/>
          <p:nvPr/>
        </p:nvCxnSpPr>
        <p:spPr>
          <a:xfrm>
            <a:off x="3477294" y="2198030"/>
            <a:ext cx="0" cy="519144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6" name="表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20118155"/>
              </p:ext>
            </p:extLst>
          </p:nvPr>
        </p:nvGraphicFramePr>
        <p:xfrm>
          <a:off x="1163818" y="7364625"/>
          <a:ext cx="4626949" cy="9448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4626949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20620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 Analysis (n=27)</a:t>
                      </a:r>
                      <a:endParaRPr kumimoji="1" lang="ja-JP" altLang="en-US" sz="14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  <a:tr h="35328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the above exclusion criteria are met during the test or if the participant requests to withdraw from the test, they will be excluded from the analysis.</a:t>
                      </a:r>
                      <a:endParaRPr kumimoji="1" lang="ja-JP" altLang="en-US" sz="12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540998"/>
                  </a:ext>
                </a:extLst>
              </a:tr>
            </a:tbl>
          </a:graphicData>
        </a:graphic>
      </p:graphicFrame>
      <p:cxnSp>
        <p:nvCxnSpPr>
          <p:cNvPr id="17" name="直線矢印コネクタ 16"/>
          <p:cNvCxnSpPr/>
          <p:nvPr/>
        </p:nvCxnSpPr>
        <p:spPr>
          <a:xfrm>
            <a:off x="3477294" y="6989259"/>
            <a:ext cx="0" cy="362488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表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853248"/>
              </p:ext>
            </p:extLst>
          </p:nvPr>
        </p:nvGraphicFramePr>
        <p:xfrm>
          <a:off x="3766394" y="655514"/>
          <a:ext cx="1342141" cy="259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42141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</a:t>
                      </a:r>
                      <a:r>
                        <a:rPr kumimoji="1" lang="ja-JP" alt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66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</a:tbl>
          </a:graphicData>
        </a:graphic>
      </p:graphicFrame>
      <p:cxnSp>
        <p:nvCxnSpPr>
          <p:cNvPr id="13" name="直線矢印コネクタ 12"/>
          <p:cNvCxnSpPr/>
          <p:nvPr/>
        </p:nvCxnSpPr>
        <p:spPr>
          <a:xfrm>
            <a:off x="3477292" y="787892"/>
            <a:ext cx="26370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8" name="表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6374524"/>
              </p:ext>
            </p:extLst>
          </p:nvPr>
        </p:nvGraphicFramePr>
        <p:xfrm>
          <a:off x="3766394" y="2305920"/>
          <a:ext cx="1342141" cy="2590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42141">
                  <a:extLst>
                    <a:ext uri="{9D8B030D-6E8A-4147-A177-3AD203B41FA5}">
                      <a16:colId xmlns:a16="http://schemas.microsoft.com/office/drawing/2014/main" val="267576469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</a:t>
                      </a:r>
                      <a:r>
                        <a:rPr kumimoji="1" lang="ja-JP" altLang="en-US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kumimoji="1" lang="en-US" altLang="ja-JP" sz="11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=23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8534736"/>
                  </a:ext>
                </a:extLst>
              </a:tr>
            </a:tbl>
          </a:graphicData>
        </a:graphic>
      </p:graphicFrame>
      <p:cxnSp>
        <p:nvCxnSpPr>
          <p:cNvPr id="19" name="直線矢印コネクタ 18"/>
          <p:cNvCxnSpPr/>
          <p:nvPr/>
        </p:nvCxnSpPr>
        <p:spPr>
          <a:xfrm>
            <a:off x="3477292" y="2438298"/>
            <a:ext cx="263702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42263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</a:t>
            </a:r>
            <a:r>
              <a:rPr lang="en-US" altLang="ja-JP" sz="1069" dirty="0" smtClean="0"/>
              <a:t>Fig.2</a:t>
            </a:r>
            <a:endParaRPr lang="ja-JP" altLang="en-US" sz="1069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6858000" cy="69656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30727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6" name="グラフ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5805143"/>
              </p:ext>
            </p:extLst>
          </p:nvPr>
        </p:nvGraphicFramePr>
        <p:xfrm>
          <a:off x="258562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9" name="グラフ 4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1197652"/>
              </p:ext>
            </p:extLst>
          </p:nvPr>
        </p:nvGraphicFramePr>
        <p:xfrm>
          <a:off x="2161212" y="189671"/>
          <a:ext cx="1728000" cy="141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2179A1DC-04D3-4B2B-ADAD-238E289CF53D}"/>
              </a:ext>
            </a:extLst>
          </p:cNvPr>
          <p:cNvSpPr txBox="1"/>
          <p:nvPr/>
        </p:nvSpPr>
        <p:spPr>
          <a:xfrm>
            <a:off x="5200650" y="8887139"/>
            <a:ext cx="1657350" cy="256861"/>
          </a:xfrm>
          <a:prstGeom prst="rect">
            <a:avLst/>
          </a:prstGeom>
          <a:noFill/>
        </p:spPr>
        <p:txBody>
          <a:bodyPr wrap="square" lIns="91436" tIns="45718" rIns="91436" bIns="45718" rtlCol="0">
            <a:spAutoFit/>
          </a:bodyPr>
          <a:lstStyle/>
          <a:p>
            <a:pPr algn="ctr"/>
            <a:r>
              <a:rPr lang="en-US" altLang="ja-JP" sz="1069" dirty="0" smtClean="0"/>
              <a:t>Supplemental </a:t>
            </a:r>
            <a:r>
              <a:rPr lang="en-US" altLang="ja-JP" sz="1069" dirty="0" smtClean="0"/>
              <a:t>Fig.3</a:t>
            </a:r>
            <a:endParaRPr lang="ja-JP" altLang="en-US" sz="1069" dirty="0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-468447" y="634112"/>
            <a:ext cx="1398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fecation frequency [counts/week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 rot="16200000">
            <a:off x="1427182" y="695668"/>
            <a:ext cx="13985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ristol stool form</a:t>
            </a:r>
            <a:r>
              <a:rPr kumimoji="1" lang="ja-JP" alt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[points]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-50801" y="1984"/>
            <a:ext cx="409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476F12A0-6CD0-43C2-BBBB-9C9BE7F3BEC2}"/>
              </a:ext>
            </a:extLst>
          </p:cNvPr>
          <p:cNvSpPr txBox="1"/>
          <p:nvPr/>
        </p:nvSpPr>
        <p:spPr>
          <a:xfrm>
            <a:off x="1866879" y="1984"/>
            <a:ext cx="4095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01966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003</TotalTime>
  <Words>357</Words>
  <Application>Microsoft Office PowerPoint</Application>
  <PresentationFormat>画面に合わせる (4:3)</PresentationFormat>
  <Paragraphs>34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9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々木裕之</dc:creator>
  <cp:lastModifiedBy>Sasaki.H/佐々木 裕之</cp:lastModifiedBy>
  <cp:revision>912</cp:revision>
  <cp:lastPrinted>2021-05-28T01:29:58Z</cp:lastPrinted>
  <dcterms:created xsi:type="dcterms:W3CDTF">2018-02-14T07:20:13Z</dcterms:created>
  <dcterms:modified xsi:type="dcterms:W3CDTF">2025-03-05T02:32:20Z</dcterms:modified>
</cp:coreProperties>
</file>